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jpeg" ContentType="image/jpeg"/>
  <Override PartName="/ppt/media/image4.png" ContentType="image/png"/>
  <Override PartName="/ppt/media/image5.png" ContentType="image/png"/>
  <Override PartName="/ppt/media/image6.jpeg" ContentType="image/jpeg"/>
  <Override PartName="/ppt/media/image8.png" ContentType="image/png"/>
  <Override PartName="/ppt/media/image7.png" ContentType="image/png"/>
  <Override PartName="/ppt/media/image9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E27FCC-4764-4C29-9B02-148B121ADC7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6DE763-5E08-4784-8FC9-F7C153B5AB1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147873-56DD-45CE-A313-F71E58CBA00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F5A0CA-147F-4476-8BBC-A6504C84CC6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 rtl="1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EDE3DB-2C11-40AB-B9A4-501B54FDF9C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8B4B26-6ED3-471C-9493-A8B5C29006D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0A329D-86B8-45E4-8B43-7E375A324CF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C973DB-1013-4BBE-B850-A3CBEBE8F6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 rtl="1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C0BF13-4227-4C2F-AE62-590B02CE4B3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08F2FE-9B24-4F39-A449-9DD8C6807B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C9DAF6-927D-488B-B902-B0E443D916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51BA8F-79B6-408A-A75F-1BF76A2C3C5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E538DD9-CEA9-4E3E-9D16-12B7F2F6FCA3}" type="slidenum">
              <a:rPr b="0" lang="he-IL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image" Target="../media/image6.jpeg"/><Relationship Id="rId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image" Target="../media/image9.jpe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3"/>
          <p:cNvSpPr/>
          <p:nvPr/>
        </p:nvSpPr>
        <p:spPr>
          <a:xfrm>
            <a:off x="333360" y="468360"/>
            <a:ext cx="5975280" cy="1150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Material for the manuscript 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4"/>
          <p:cNvSpPr/>
          <p:nvPr/>
        </p:nvSpPr>
        <p:spPr>
          <a:xfrm>
            <a:off x="333360" y="2309760"/>
            <a:ext cx="5975280" cy="259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econstitution of Pure Chaperonin Hetero-Oligomer Preparations in Vitro by Temperature Modula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nna Vitlin Gruber</a:t>
            </a:r>
            <a:r>
              <a:rPr b="0" lang="en-US" sz="16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, Milena Vugman</a:t>
            </a:r>
            <a:r>
              <a:rPr b="0" lang="en-US" sz="16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, Abdussalam Azem</a:t>
            </a:r>
            <a:r>
              <a:rPr b="0" lang="en-US" sz="16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and Celeste Weiss</a:t>
            </a:r>
            <a:r>
              <a:rPr b="0" lang="en-US" sz="16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 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. Department of Molecular, Cell and Developmental Biology, University of California Los Angeles, Los Angeles, CA 90095, USA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. George S. Wise Faculty of Life Sciences, Department of Biochemistry and Molecular Biology, Tel Aviv University, Tel Aviv 69978, Israe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corresponding author: celeste@tauex.tau.ac.il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Picture 769" descr=""/>
          <p:cNvPicPr/>
          <p:nvPr/>
        </p:nvPicPr>
        <p:blipFill>
          <a:blip r:embed="rId1"/>
          <a:srcRect l="-5130" t="-4979" r="-14243" b="-13427"/>
          <a:stretch/>
        </p:blipFill>
        <p:spPr>
          <a:xfrm>
            <a:off x="476280" y="5435640"/>
            <a:ext cx="4176720" cy="302400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5" descr=""/>
          <p:cNvPicPr/>
          <p:nvPr/>
        </p:nvPicPr>
        <p:blipFill>
          <a:blip r:embed="rId2">
            <a:grayscl/>
          </a:blip>
          <a:srcRect l="-3285" t="-1703" r="-479" b="-13141"/>
          <a:stretch/>
        </p:blipFill>
        <p:spPr>
          <a:xfrm>
            <a:off x="620640" y="900000"/>
            <a:ext cx="3197160" cy="223200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6" descr=""/>
          <p:cNvPicPr/>
          <p:nvPr/>
        </p:nvPicPr>
        <p:blipFill>
          <a:blip r:embed="rId3">
            <a:grayscl/>
          </a:blip>
          <a:srcRect l="-2743" t="-1638" r="-3270" b="-3952"/>
          <a:stretch/>
        </p:blipFill>
        <p:spPr>
          <a:xfrm>
            <a:off x="620640" y="3276720"/>
            <a:ext cx="3283200" cy="1871640"/>
          </a:xfrm>
          <a:prstGeom prst="rect">
            <a:avLst/>
          </a:prstGeom>
          <a:ln w="0">
            <a:noFill/>
          </a:ln>
        </p:spPr>
      </p:pic>
      <p:sp>
        <p:nvSpPr>
          <p:cNvPr id="46" name="TextBox 2"/>
          <p:cNvSpPr/>
          <p:nvPr/>
        </p:nvSpPr>
        <p:spPr>
          <a:xfrm>
            <a:off x="673200" y="611280"/>
            <a:ext cx="143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- top pan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7"/>
          <p:cNvSpPr/>
          <p:nvPr/>
        </p:nvSpPr>
        <p:spPr>
          <a:xfrm>
            <a:off x="587520" y="5187960"/>
            <a:ext cx="1081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8"/>
          <p:cNvSpPr/>
          <p:nvPr/>
        </p:nvSpPr>
        <p:spPr>
          <a:xfrm>
            <a:off x="646200" y="2987640"/>
            <a:ext cx="1800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- bottom pan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0"/>
          <p:cNvSpPr/>
          <p:nvPr/>
        </p:nvSpPr>
        <p:spPr>
          <a:xfrm>
            <a:off x="654120" y="141120"/>
            <a:ext cx="143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"/>
          <p:cNvSpPr/>
          <p:nvPr/>
        </p:nvSpPr>
        <p:spPr>
          <a:xfrm>
            <a:off x="620640" y="8459640"/>
            <a:ext cx="6048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igure S1: Original  gels used to prepare Figures 1 A and 1 B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Picture 5" descr=""/>
          <p:cNvPicPr/>
          <p:nvPr/>
        </p:nvPicPr>
        <p:blipFill>
          <a:blip r:embed="rId1"/>
          <a:srcRect l="-25316" t="-12206" r="-19458" b="-86"/>
          <a:stretch/>
        </p:blipFill>
        <p:spPr>
          <a:xfrm>
            <a:off x="44280" y="468360"/>
            <a:ext cx="2880000" cy="233820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6" descr=""/>
          <p:cNvPicPr/>
          <p:nvPr/>
        </p:nvPicPr>
        <p:blipFill>
          <a:blip r:embed="rId2"/>
          <a:srcRect l="-14232" t="-5626" r="-14268" b="-3744"/>
          <a:stretch/>
        </p:blipFill>
        <p:spPr>
          <a:xfrm>
            <a:off x="297000" y="2987640"/>
            <a:ext cx="2592360" cy="194472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7" descr=""/>
          <p:cNvPicPr/>
          <p:nvPr/>
        </p:nvPicPr>
        <p:blipFill>
          <a:blip r:embed="rId3">
            <a:grayscl/>
            <a:lum bright="6000"/>
          </a:blip>
          <a:srcRect l="-11157" t="-5628" r="-23077" b="-23867"/>
          <a:stretch/>
        </p:blipFill>
        <p:spPr>
          <a:xfrm>
            <a:off x="297000" y="5167440"/>
            <a:ext cx="2592360" cy="2340000"/>
          </a:xfrm>
          <a:prstGeom prst="rect">
            <a:avLst/>
          </a:prstGeom>
          <a:ln w="0">
            <a:noFill/>
          </a:ln>
        </p:spPr>
      </p:pic>
      <p:sp>
        <p:nvSpPr>
          <p:cNvPr id="54" name="TextBox 1"/>
          <p:cNvSpPr/>
          <p:nvPr/>
        </p:nvSpPr>
        <p:spPr>
          <a:xfrm>
            <a:off x="521640" y="179280"/>
            <a:ext cx="116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5"/>
          <p:cNvSpPr/>
          <p:nvPr/>
        </p:nvSpPr>
        <p:spPr>
          <a:xfrm>
            <a:off x="2789640" y="971640"/>
            <a:ext cx="941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op g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6"/>
          <p:cNvSpPr/>
          <p:nvPr/>
        </p:nvSpPr>
        <p:spPr>
          <a:xfrm>
            <a:off x="2804760" y="3483000"/>
            <a:ext cx="1218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ddle g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7"/>
          <p:cNvSpPr/>
          <p:nvPr/>
        </p:nvSpPr>
        <p:spPr>
          <a:xfrm>
            <a:off x="2803320" y="5651640"/>
            <a:ext cx="1271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ottom g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1"/>
          <p:cNvSpPr/>
          <p:nvPr/>
        </p:nvSpPr>
        <p:spPr>
          <a:xfrm>
            <a:off x="441360" y="7453440"/>
            <a:ext cx="504036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igure S2: Original  gels used to prepare the Top, Middle and Bottom panels of Figure 2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Picture 37" descr=""/>
          <p:cNvPicPr/>
          <p:nvPr/>
        </p:nvPicPr>
        <p:blipFill>
          <a:blip r:embed="rId1"/>
          <a:srcRect l="-5563" t="-4615" r="-6333" b="-6529"/>
          <a:stretch/>
        </p:blipFill>
        <p:spPr>
          <a:xfrm>
            <a:off x="287280" y="2976480"/>
            <a:ext cx="3743280" cy="238752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57" descr=""/>
          <p:cNvPicPr/>
          <p:nvPr/>
        </p:nvPicPr>
        <p:blipFill>
          <a:blip r:embed="rId2"/>
          <a:srcRect l="-6031" t="-6759" r="-6693" b="-8481"/>
          <a:stretch/>
        </p:blipFill>
        <p:spPr>
          <a:xfrm>
            <a:off x="287280" y="5199120"/>
            <a:ext cx="3875040" cy="254160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2" descr=""/>
          <p:cNvPicPr/>
          <p:nvPr/>
        </p:nvPicPr>
        <p:blipFill>
          <a:blip r:embed="rId3">
            <a:grayscl/>
          </a:blip>
          <a:srcRect l="-9371" t="-4798" r="-9935" b="-4369"/>
          <a:stretch/>
        </p:blipFill>
        <p:spPr>
          <a:xfrm>
            <a:off x="155520" y="598320"/>
            <a:ext cx="3970440" cy="2318040"/>
          </a:xfrm>
          <a:prstGeom prst="rect">
            <a:avLst/>
          </a:prstGeom>
          <a:ln w="0">
            <a:noFill/>
          </a:ln>
        </p:spPr>
      </p:pic>
      <p:sp>
        <p:nvSpPr>
          <p:cNvPr id="62" name="TextBox 6"/>
          <p:cNvSpPr/>
          <p:nvPr/>
        </p:nvSpPr>
        <p:spPr>
          <a:xfrm>
            <a:off x="353520" y="169920"/>
            <a:ext cx="116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7"/>
          <p:cNvSpPr/>
          <p:nvPr/>
        </p:nvSpPr>
        <p:spPr>
          <a:xfrm>
            <a:off x="4149720" y="1682640"/>
            <a:ext cx="1089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op g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8"/>
          <p:cNvSpPr/>
          <p:nvPr/>
        </p:nvSpPr>
        <p:spPr>
          <a:xfrm>
            <a:off x="4149720" y="3924360"/>
            <a:ext cx="1366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ddle g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9"/>
          <p:cNvSpPr/>
          <p:nvPr/>
        </p:nvSpPr>
        <p:spPr>
          <a:xfrm>
            <a:off x="4149720" y="6443640"/>
            <a:ext cx="1366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ottom  g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10"/>
          <p:cNvSpPr/>
          <p:nvPr/>
        </p:nvSpPr>
        <p:spPr>
          <a:xfrm>
            <a:off x="468360" y="7742160"/>
            <a:ext cx="504036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igure S3: Original  gels used to prepare the Top, Middle and Bottom panels of Figure 3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5-01T07:36:15Z</dcterms:created>
  <dc:creator>AzemA4</dc:creator>
  <dc:description/>
  <dc:language>en-US</dc:language>
  <cp:lastModifiedBy>user</cp:lastModifiedBy>
  <dcterms:modified xsi:type="dcterms:W3CDTF">2018-01-18T09:06:07Z</dcterms:modified>
  <cp:revision>33</cp:revision>
  <dc:subject/>
  <dc:title>Slide 1</dc:title>
</cp:coreProperties>
</file>